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402BF5-329A-4FE5-93FB-F49DD74A45FB}" v="17" dt="2020-08-15T15:09:05.25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396" y="-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惟大 葉山" userId="fc439ddad3c11fe1" providerId="LiveId" clId="{67A71D86-5222-44BB-AE8E-F2298617840B}"/>
    <pc:docChg chg="undo custSel modSld">
      <pc:chgData name="惟大 葉山" userId="fc439ddad3c11fe1" providerId="LiveId" clId="{67A71D86-5222-44BB-AE8E-F2298617840B}" dt="2020-04-26T10:58:00.188" v="124" actId="207"/>
      <pc:docMkLst>
        <pc:docMk/>
      </pc:docMkLst>
      <pc:sldChg chg="modSp">
        <pc:chgData name="惟大 葉山" userId="fc439ddad3c11fe1" providerId="LiveId" clId="{67A71D86-5222-44BB-AE8E-F2298617840B}" dt="2020-04-26T10:58:00.188" v="124" actId="207"/>
        <pc:sldMkLst>
          <pc:docMk/>
          <pc:sldMk cId="4137066546" sldId="256"/>
        </pc:sldMkLst>
        <pc:spChg chg="mod">
          <ac:chgData name="惟大 葉山" userId="fc439ddad3c11fe1" providerId="LiveId" clId="{67A71D86-5222-44BB-AE8E-F2298617840B}" dt="2020-03-29T06:46:43.338" v="8" actId="1076"/>
          <ac:spMkLst>
            <pc:docMk/>
            <pc:sldMk cId="4137066546" sldId="256"/>
            <ac:spMk id="6" creationId="{00000000-0000-0000-0000-000000000000}"/>
          </ac:spMkLst>
        </pc:spChg>
        <pc:graphicFrameChg chg="mod modGraphic">
          <ac:chgData name="惟大 葉山" userId="fc439ddad3c11fe1" providerId="LiveId" clId="{67A71D86-5222-44BB-AE8E-F2298617840B}" dt="2020-04-26T10:58:00.188" v="124" actId="207"/>
          <ac:graphicFrameMkLst>
            <pc:docMk/>
            <pc:sldMk cId="4137066546" sldId="256"/>
            <ac:graphicFrameMk id="5" creationId="{00000000-0000-0000-0000-000000000000}"/>
          </ac:graphicFrameMkLst>
        </pc:graphicFrameChg>
      </pc:sldChg>
    </pc:docChg>
  </pc:docChgLst>
  <pc:docChgLst>
    <pc:chgData name="惟大 葉山" userId="fc439ddad3c11fe1" providerId="LiveId" clId="{AB9AD7CC-5BA1-4594-869A-B69FB808D0C6}"/>
    <pc:docChg chg="undo custSel addSld modSld">
      <pc:chgData name="惟大 葉山" userId="fc439ddad3c11fe1" providerId="LiveId" clId="{AB9AD7CC-5BA1-4594-869A-B69FB808D0C6}" dt="2020-08-10T15:01:39.228" v="557" actId="947"/>
      <pc:docMkLst>
        <pc:docMk/>
      </pc:docMkLst>
      <pc:sldChg chg="modSp mod">
        <pc:chgData name="惟大 葉山" userId="fc439ddad3c11fe1" providerId="LiveId" clId="{AB9AD7CC-5BA1-4594-869A-B69FB808D0C6}" dt="2020-08-10T14:57:59.822" v="366" actId="20577"/>
        <pc:sldMkLst>
          <pc:docMk/>
          <pc:sldMk cId="4137066546" sldId="256"/>
        </pc:sldMkLst>
        <pc:spChg chg="mod">
          <ac:chgData name="惟大 葉山" userId="fc439ddad3c11fe1" providerId="LiveId" clId="{AB9AD7CC-5BA1-4594-869A-B69FB808D0C6}" dt="2020-08-10T14:57:59.822" v="366" actId="20577"/>
          <ac:spMkLst>
            <pc:docMk/>
            <pc:sldMk cId="4137066546" sldId="256"/>
            <ac:spMk id="6" creationId="{00000000-0000-0000-0000-000000000000}"/>
          </ac:spMkLst>
        </pc:spChg>
        <pc:graphicFrameChg chg="mod modGraphic">
          <ac:chgData name="惟大 葉山" userId="fc439ddad3c11fe1" providerId="LiveId" clId="{AB9AD7CC-5BA1-4594-869A-B69FB808D0C6}" dt="2020-07-26T02:56:08.089" v="362" actId="20577"/>
          <ac:graphicFrameMkLst>
            <pc:docMk/>
            <pc:sldMk cId="4137066546" sldId="256"/>
            <ac:graphicFrameMk id="5" creationId="{00000000-0000-0000-0000-000000000000}"/>
          </ac:graphicFrameMkLst>
        </pc:graphicFrameChg>
      </pc:sldChg>
      <pc:sldChg chg="modSp add mod">
        <pc:chgData name="惟大 葉山" userId="fc439ddad3c11fe1" providerId="LiveId" clId="{AB9AD7CC-5BA1-4594-869A-B69FB808D0C6}" dt="2020-08-10T14:58:04.644" v="368" actId="20577"/>
        <pc:sldMkLst>
          <pc:docMk/>
          <pc:sldMk cId="289235180" sldId="257"/>
        </pc:sldMkLst>
        <pc:spChg chg="mod">
          <ac:chgData name="惟大 葉山" userId="fc439ddad3c11fe1" providerId="LiveId" clId="{AB9AD7CC-5BA1-4594-869A-B69FB808D0C6}" dt="2020-08-10T14:58:04.644" v="368" actId="20577"/>
          <ac:spMkLst>
            <pc:docMk/>
            <pc:sldMk cId="289235180" sldId="257"/>
            <ac:spMk id="6" creationId="{00000000-0000-0000-0000-000000000000}"/>
          </ac:spMkLst>
        </pc:spChg>
        <pc:graphicFrameChg chg="mod modGraphic">
          <ac:chgData name="惟大 葉山" userId="fc439ddad3c11fe1" providerId="LiveId" clId="{AB9AD7CC-5BA1-4594-869A-B69FB808D0C6}" dt="2020-07-26T02:55:53.938" v="347" actId="113"/>
          <ac:graphicFrameMkLst>
            <pc:docMk/>
            <pc:sldMk cId="289235180" sldId="257"/>
            <ac:graphicFrameMk id="5" creationId="{00000000-0000-0000-0000-000000000000}"/>
          </ac:graphicFrameMkLst>
        </pc:graphicFrameChg>
      </pc:sldChg>
      <pc:sldChg chg="modSp mod">
        <pc:chgData name="惟大 葉山" userId="fc439ddad3c11fe1" providerId="LiveId" clId="{AB9AD7CC-5BA1-4594-869A-B69FB808D0C6}" dt="2020-08-10T15:01:39.228" v="557" actId="947"/>
        <pc:sldMkLst>
          <pc:docMk/>
          <pc:sldMk cId="470536657" sldId="258"/>
        </pc:sldMkLst>
        <pc:graphicFrameChg chg="mod modGraphic">
          <ac:chgData name="惟大 葉山" userId="fc439ddad3c11fe1" providerId="LiveId" clId="{AB9AD7CC-5BA1-4594-869A-B69FB808D0C6}" dt="2020-08-10T15:01:39.228" v="557" actId="947"/>
          <ac:graphicFrameMkLst>
            <pc:docMk/>
            <pc:sldMk cId="470536657" sldId="258"/>
            <ac:graphicFrameMk id="5" creationId="{00000000-0000-0000-0000-000000000000}"/>
          </ac:graphicFrameMkLst>
        </pc:graphicFrameChg>
      </pc:sldChg>
    </pc:docChg>
  </pc:docChgLst>
  <pc:docChgLst>
    <pc:chgData name="惟大 葉山" userId="fc439ddad3c11fe1" providerId="LiveId" clId="{E2402BF5-329A-4FE5-93FB-F49DD74A45FB}"/>
    <pc:docChg chg="modSld">
      <pc:chgData name="惟大 葉山" userId="fc439ddad3c11fe1" providerId="LiveId" clId="{E2402BF5-329A-4FE5-93FB-F49DD74A45FB}" dt="2020-08-15T15:09:16.905" v="78" actId="20577"/>
      <pc:docMkLst>
        <pc:docMk/>
      </pc:docMkLst>
      <pc:sldChg chg="modSp mod">
        <pc:chgData name="惟大 葉山" userId="fc439ddad3c11fe1" providerId="LiveId" clId="{E2402BF5-329A-4FE5-93FB-F49DD74A45FB}" dt="2020-08-15T15:09:16.905" v="78" actId="20577"/>
        <pc:sldMkLst>
          <pc:docMk/>
          <pc:sldMk cId="289235180" sldId="257"/>
        </pc:sldMkLst>
        <pc:graphicFrameChg chg="mod modGraphic">
          <ac:chgData name="惟大 葉山" userId="fc439ddad3c11fe1" providerId="LiveId" clId="{E2402BF5-329A-4FE5-93FB-F49DD74A45FB}" dt="2020-08-15T15:09:16.905" v="78" actId="20577"/>
          <ac:graphicFrameMkLst>
            <pc:docMk/>
            <pc:sldMk cId="289235180" sldId="257"/>
            <ac:graphicFrameMk id="5" creationId="{00000000-0000-0000-0000-00000000000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0/9/12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2151013"/>
              </p:ext>
            </p:extLst>
          </p:nvPr>
        </p:nvGraphicFramePr>
        <p:xfrm>
          <a:off x="1115616" y="836712"/>
          <a:ext cx="6984776" cy="463075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5434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64347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64347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643477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470397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st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ased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n 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7</a:t>
                      </a:r>
                      <a:endParaRPr kumimoji="1" lang="en-US" altLang="ja-JP" sz="14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 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ased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n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 standard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</a:t>
                      </a:r>
                      <a:r>
                        <a:rPr kumimoji="1" lang="en-US" altLang="ja-JP" sz="14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kumimoji="1" lang="ja-JP" altLang="en-US" sz="14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6738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 functioning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28±19.82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2±13.17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14</a:t>
                      </a:r>
                      <a:r>
                        <a:rPr kumimoji="1" lang="en-US" altLang="ja-JP" sz="1050" b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le physical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05±15.55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27±12.64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</a:t>
                      </a:r>
                      <a:r>
                        <a:rPr kumimoji="1" lang="en-US" altLang="ja-JP" sz="105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ily pain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13±13.20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90±12.76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85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health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84±10.27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21±8.57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kumimoji="1" lang="ja-JP" altLang="en-US" sz="105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5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r>
                        <a:rPr kumimoji="1" lang="en-US" altLang="ja-JP" sz="1050" b="1" i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alit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07±11.20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40±10.1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01</a:t>
                      </a:r>
                      <a:r>
                        <a:rPr kumimoji="1" lang="en-US" altLang="ja-JP" sz="1050" b="1" i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 functioning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51±14.63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01±10.84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01</a:t>
                      </a:r>
                      <a:r>
                        <a:rPr kumimoji="1" lang="en-US" altLang="ja-JP" sz="1050" b="1" i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le emotional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74±15.13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30±13.31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3</a:t>
                      </a:r>
                      <a:r>
                        <a:rPr kumimoji="1" lang="en-US" altLang="ja-JP" sz="105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4640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tal health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0±11.34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01±11.71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01</a:t>
                      </a:r>
                      <a:r>
                        <a:rPr kumimoji="1" lang="en-US" altLang="ja-JP" sz="105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※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2000250" y="5535235"/>
            <a:ext cx="55240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: Comparison of T-scores of SF-36v2 subscales calculated from respective coeval standard between past and present GPP patients</a:t>
            </a:r>
          </a:p>
        </p:txBody>
      </p:sp>
    </p:spTree>
    <p:extLst>
      <p:ext uri="{BB962C8B-B14F-4D97-AF65-F5344CB8AC3E}">
        <p14:creationId xmlns:p14="http://schemas.microsoft.com/office/powerpoint/2010/main" val="289235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86</Words>
  <Application>Microsoft Office PowerPoint</Application>
  <PresentationFormat>画面に合わせる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葉山惟大</dc:creator>
  <cp:lastModifiedBy>葉山　惟大</cp:lastModifiedBy>
  <cp:revision>10</cp:revision>
  <cp:lastPrinted>2020-04-26T10:46:07Z</cp:lastPrinted>
  <dcterms:created xsi:type="dcterms:W3CDTF">2020-03-24T10:23:39Z</dcterms:created>
  <dcterms:modified xsi:type="dcterms:W3CDTF">2020-09-12T08:09:53Z</dcterms:modified>
</cp:coreProperties>
</file>